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6858000" cy="9144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371" autoAdjust="0"/>
  </p:normalViewPr>
  <p:slideViewPr>
    <p:cSldViewPr>
      <p:cViewPr>
        <p:scale>
          <a:sx n="98" d="100"/>
          <a:sy n="98" d="100"/>
        </p:scale>
        <p:origin x="-2856" y="-144"/>
      </p:cViewPr>
      <p:guideLst>
        <p:guide orient="horz" pos="2880"/>
        <p:guide pos="8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55FBCD-D318-4371-8053-EFBBC77DAA6F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691063"/>
            <a:ext cx="5438775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6EA6F4-1D04-4C20-A904-748DDB3FEE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911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362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762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99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436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250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910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1381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315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966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216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58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148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04664" y="272578"/>
            <a:ext cx="1707164" cy="4731470"/>
            <a:chOff x="0" y="-6326"/>
            <a:chExt cx="1707164" cy="4731470"/>
          </a:xfrm>
        </p:grpSpPr>
        <p:grpSp>
          <p:nvGrpSpPr>
            <p:cNvPr id="5" name="Group 4"/>
            <p:cNvGrpSpPr/>
            <p:nvPr/>
          </p:nvGrpSpPr>
          <p:grpSpPr>
            <a:xfrm>
              <a:off x="0" y="-6326"/>
              <a:ext cx="1707164" cy="4731470"/>
              <a:chOff x="0" y="-6326"/>
              <a:chExt cx="1707164" cy="4731470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29214" y="68978"/>
                <a:ext cx="1577950" cy="4656166"/>
                <a:chOff x="2071353" y="141599"/>
                <a:chExt cx="1577950" cy="4656166"/>
              </a:xfrm>
            </p:grpSpPr>
            <p:grpSp>
              <p:nvGrpSpPr>
                <p:cNvPr id="9" name="Group 8"/>
                <p:cNvGrpSpPr/>
                <p:nvPr/>
              </p:nvGrpSpPr>
              <p:grpSpPr>
                <a:xfrm>
                  <a:off x="2199075" y="141599"/>
                  <a:ext cx="1438214" cy="1491380"/>
                  <a:chOff x="165209" y="44624"/>
                  <a:chExt cx="1438214" cy="1491380"/>
                </a:xfrm>
              </p:grpSpPr>
              <p:pic>
                <p:nvPicPr>
                  <p:cNvPr id="31" name="Grafik 1"/>
                  <p:cNvPicPr/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3691" t="72536" r="63864"/>
                  <a:stretch/>
                </p:blipFill>
                <p:spPr>
                  <a:xfrm>
                    <a:off x="279252" y="367209"/>
                    <a:ext cx="1248229" cy="1168795"/>
                  </a:xfrm>
                  <a:prstGeom prst="rect">
                    <a:avLst/>
                  </a:prstGeom>
                </p:spPr>
              </p:pic>
              <p:sp>
                <p:nvSpPr>
                  <p:cNvPr id="32" name="TextBox 31"/>
                  <p:cNvSpPr txBox="1"/>
                  <p:nvPr/>
                </p:nvSpPr>
                <p:spPr>
                  <a:xfrm>
                    <a:off x="165209" y="177607"/>
                    <a:ext cx="1438214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100" dirty="0" smtClean="0"/>
                      <a:t>G  </a:t>
                    </a:r>
                    <a:r>
                      <a:rPr lang="en-GB" sz="1100" dirty="0" smtClean="0">
                        <a:solidFill>
                          <a:schemeClr val="tx2">
                            <a:lumMod val="75000"/>
                          </a:schemeClr>
                        </a:solidFill>
                      </a:rPr>
                      <a:t>C</a:t>
                    </a:r>
                    <a:r>
                      <a:rPr lang="en-GB" sz="1100" dirty="0" smtClean="0"/>
                      <a:t>  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A</a:t>
                    </a:r>
                    <a:r>
                      <a:rPr lang="en-GB" sz="1100" dirty="0" smtClean="0"/>
                      <a:t>  G  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A  </a:t>
                    </a:r>
                    <a:r>
                      <a:rPr lang="en-GB" sz="1100" dirty="0" err="1" smtClean="0">
                        <a:solidFill>
                          <a:srgbClr val="00B050"/>
                        </a:solidFill>
                      </a:rPr>
                      <a:t>A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  </a:t>
                    </a:r>
                    <a:r>
                      <a:rPr lang="en-GB" sz="1100" dirty="0" err="1" smtClean="0">
                        <a:solidFill>
                          <a:srgbClr val="00B050"/>
                        </a:solidFill>
                      </a:rPr>
                      <a:t>A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  </a:t>
                    </a:r>
                    <a:r>
                      <a:rPr lang="en-GB" sz="1100" dirty="0" smtClean="0"/>
                      <a:t>G  </a:t>
                    </a:r>
                    <a:r>
                      <a:rPr lang="en-GB" sz="1100" dirty="0" smtClean="0">
                        <a:solidFill>
                          <a:srgbClr val="FF0000"/>
                        </a:solidFill>
                      </a:rPr>
                      <a:t>T</a:t>
                    </a:r>
                    <a:endParaRPr lang="en-GB" sz="1100" dirty="0">
                      <a:solidFill>
                        <a:srgbClr val="FF0000"/>
                      </a:solidFill>
                    </a:endParaRPr>
                  </a:p>
                </p:txBody>
              </p:sp>
              <p:cxnSp>
                <p:nvCxnSpPr>
                  <p:cNvPr id="33" name="Straight Connector 32"/>
                  <p:cNvCxnSpPr/>
                  <p:nvPr/>
                </p:nvCxnSpPr>
                <p:spPr>
                  <a:xfrm>
                    <a:off x="850539" y="249615"/>
                    <a:ext cx="360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" name="Straight Connector 33"/>
                  <p:cNvCxnSpPr/>
                  <p:nvPr/>
                </p:nvCxnSpPr>
                <p:spPr>
                  <a:xfrm>
                    <a:off x="418539" y="249615"/>
                    <a:ext cx="360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" name="Straight Connector 34"/>
                  <p:cNvCxnSpPr/>
                  <p:nvPr/>
                </p:nvCxnSpPr>
                <p:spPr>
                  <a:xfrm>
                    <a:off x="256267" y="249615"/>
                    <a:ext cx="1188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Straight Connector 35"/>
                  <p:cNvCxnSpPr/>
                  <p:nvPr/>
                </p:nvCxnSpPr>
                <p:spPr>
                  <a:xfrm>
                    <a:off x="1264379" y="249615"/>
                    <a:ext cx="2376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7" name="TextBox 36"/>
                  <p:cNvSpPr txBox="1"/>
                  <p:nvPr/>
                </p:nvSpPr>
                <p:spPr>
                  <a:xfrm>
                    <a:off x="816949" y="44624"/>
                    <a:ext cx="41870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/>
                      <a:t>K</a:t>
                    </a:r>
                    <a:r>
                      <a:rPr lang="en-GB" sz="1200" baseline="30000" dirty="0" smtClean="0"/>
                      <a:t>700</a:t>
                    </a:r>
                    <a:endParaRPr lang="en-GB" sz="1200" baseline="30000" dirty="0"/>
                  </a:p>
                </p:txBody>
              </p: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389581" y="44624"/>
                    <a:ext cx="44275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/>
                      <a:t>Q</a:t>
                    </a:r>
                    <a:r>
                      <a:rPr lang="en-GB" sz="1200" baseline="30000" dirty="0"/>
                      <a:t>6</a:t>
                    </a:r>
                    <a:r>
                      <a:rPr lang="en-GB" sz="1200" baseline="30000" dirty="0" smtClean="0"/>
                      <a:t>99</a:t>
                    </a:r>
                    <a:endParaRPr lang="en-GB" sz="1200" baseline="30000" dirty="0"/>
                  </a:p>
                </p:txBody>
              </p:sp>
            </p:grpSp>
            <p:grpSp>
              <p:nvGrpSpPr>
                <p:cNvPr id="10" name="Group 9"/>
                <p:cNvGrpSpPr/>
                <p:nvPr/>
              </p:nvGrpSpPr>
              <p:grpSpPr>
                <a:xfrm>
                  <a:off x="2199075" y="1639767"/>
                  <a:ext cx="1438214" cy="1527898"/>
                  <a:chOff x="88454" y="1628800"/>
                  <a:chExt cx="1438214" cy="1527898"/>
                </a:xfrm>
              </p:grpSpPr>
              <p:pic>
                <p:nvPicPr>
                  <p:cNvPr id="23" name="Grafik 1"/>
                  <p:cNvPicPr/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3636" t="6903" r="63984" b="65655"/>
                  <a:stretch/>
                </p:blipFill>
                <p:spPr>
                  <a:xfrm>
                    <a:off x="207244" y="1988840"/>
                    <a:ext cx="1244600" cy="1167858"/>
                  </a:xfrm>
                  <a:prstGeom prst="rect">
                    <a:avLst/>
                  </a:prstGeom>
                </p:spPr>
              </p:pic>
              <p:sp>
                <p:nvSpPr>
                  <p:cNvPr id="24" name="TextBox 23"/>
                  <p:cNvSpPr txBox="1"/>
                  <p:nvPr/>
                </p:nvSpPr>
                <p:spPr>
                  <a:xfrm>
                    <a:off x="88454" y="1761783"/>
                    <a:ext cx="1438214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100" dirty="0" smtClean="0"/>
                      <a:t>G  </a:t>
                    </a:r>
                    <a:r>
                      <a:rPr lang="en-GB" sz="1100" dirty="0" smtClean="0">
                        <a:solidFill>
                          <a:schemeClr val="tx2">
                            <a:lumMod val="75000"/>
                          </a:schemeClr>
                        </a:solidFill>
                      </a:rPr>
                      <a:t>C</a:t>
                    </a:r>
                    <a:r>
                      <a:rPr lang="en-GB" sz="1100" dirty="0" smtClean="0"/>
                      <a:t>  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A</a:t>
                    </a:r>
                    <a:r>
                      <a:rPr lang="en-GB" sz="1100" dirty="0" smtClean="0"/>
                      <a:t>  G  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A  </a:t>
                    </a:r>
                    <a:r>
                      <a:rPr lang="en-GB" sz="1100" dirty="0" err="1" smtClean="0">
                        <a:solidFill>
                          <a:srgbClr val="00B050"/>
                        </a:solidFill>
                      </a:rPr>
                      <a:t>A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  </a:t>
                    </a:r>
                    <a:r>
                      <a:rPr lang="en-GB" sz="1100" dirty="0" err="1" smtClean="0">
                        <a:solidFill>
                          <a:srgbClr val="00B050"/>
                        </a:solidFill>
                      </a:rPr>
                      <a:t>A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  </a:t>
                    </a:r>
                    <a:r>
                      <a:rPr lang="en-GB" sz="1100" dirty="0" smtClean="0"/>
                      <a:t>G  </a:t>
                    </a:r>
                    <a:r>
                      <a:rPr lang="en-GB" sz="1100" dirty="0" smtClean="0">
                        <a:solidFill>
                          <a:srgbClr val="FF0000"/>
                        </a:solidFill>
                      </a:rPr>
                      <a:t>T</a:t>
                    </a:r>
                    <a:endParaRPr lang="en-GB" sz="1100" dirty="0">
                      <a:solidFill>
                        <a:srgbClr val="FF0000"/>
                      </a:solidFill>
                    </a:endParaRPr>
                  </a:p>
                </p:txBody>
              </p:sp>
              <p:cxnSp>
                <p:nvCxnSpPr>
                  <p:cNvPr id="25" name="Straight Connector 24"/>
                  <p:cNvCxnSpPr/>
                  <p:nvPr/>
                </p:nvCxnSpPr>
                <p:spPr>
                  <a:xfrm>
                    <a:off x="773784" y="1833791"/>
                    <a:ext cx="360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Straight Connector 25"/>
                  <p:cNvCxnSpPr/>
                  <p:nvPr/>
                </p:nvCxnSpPr>
                <p:spPr>
                  <a:xfrm>
                    <a:off x="341784" y="1833791"/>
                    <a:ext cx="360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" name="Straight Connector 26"/>
                  <p:cNvCxnSpPr/>
                  <p:nvPr/>
                </p:nvCxnSpPr>
                <p:spPr>
                  <a:xfrm>
                    <a:off x="179512" y="1833791"/>
                    <a:ext cx="1188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" name="Straight Connector 27"/>
                  <p:cNvCxnSpPr/>
                  <p:nvPr/>
                </p:nvCxnSpPr>
                <p:spPr>
                  <a:xfrm>
                    <a:off x="1187624" y="1833791"/>
                    <a:ext cx="2376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740194" y="1628800"/>
                    <a:ext cx="41870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/>
                      <a:t>K</a:t>
                    </a:r>
                    <a:r>
                      <a:rPr lang="en-GB" sz="1200" baseline="30000" dirty="0" smtClean="0"/>
                      <a:t>700</a:t>
                    </a:r>
                    <a:endParaRPr lang="en-GB" sz="1200" baseline="30000" dirty="0"/>
                  </a:p>
                </p:txBody>
              </p:sp>
              <p:sp>
                <p:nvSpPr>
                  <p:cNvPr id="30" name="TextBox 29"/>
                  <p:cNvSpPr txBox="1"/>
                  <p:nvPr/>
                </p:nvSpPr>
                <p:spPr>
                  <a:xfrm>
                    <a:off x="312826" y="1628800"/>
                    <a:ext cx="44275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/>
                      <a:t>Q</a:t>
                    </a:r>
                    <a:r>
                      <a:rPr lang="en-GB" sz="1200" baseline="30000" dirty="0"/>
                      <a:t>6</a:t>
                    </a:r>
                    <a:r>
                      <a:rPr lang="en-GB" sz="1200" baseline="30000" dirty="0" smtClean="0"/>
                      <a:t>99</a:t>
                    </a:r>
                    <a:endParaRPr lang="en-GB" sz="1200" baseline="30000" dirty="0"/>
                  </a:p>
                </p:txBody>
              </p:sp>
            </p:grpSp>
            <p:grpSp>
              <p:nvGrpSpPr>
                <p:cNvPr id="11" name="Group 10"/>
                <p:cNvGrpSpPr/>
                <p:nvPr/>
              </p:nvGrpSpPr>
              <p:grpSpPr>
                <a:xfrm>
                  <a:off x="2211089" y="3174454"/>
                  <a:ext cx="1438214" cy="1623311"/>
                  <a:chOff x="172476" y="3394447"/>
                  <a:chExt cx="1438214" cy="1623311"/>
                </a:xfrm>
              </p:grpSpPr>
              <p:pic>
                <p:nvPicPr>
                  <p:cNvPr id="15" name="Grafik 1"/>
                  <p:cNvPicPr/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4193" t="6605" r="13232" b="65669"/>
                  <a:stretch/>
                </p:blipFill>
                <p:spPr>
                  <a:xfrm>
                    <a:off x="279252" y="3837800"/>
                    <a:ext cx="1255485" cy="1179958"/>
                  </a:xfrm>
                  <a:prstGeom prst="rect">
                    <a:avLst/>
                  </a:prstGeom>
                </p:spPr>
              </p:pic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172476" y="3527430"/>
                    <a:ext cx="1438214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100" dirty="0" smtClean="0"/>
                      <a:t>G  </a:t>
                    </a:r>
                    <a:r>
                      <a:rPr lang="en-GB" sz="1100" dirty="0" smtClean="0">
                        <a:solidFill>
                          <a:schemeClr val="tx2">
                            <a:lumMod val="75000"/>
                          </a:schemeClr>
                        </a:solidFill>
                      </a:rPr>
                      <a:t>C</a:t>
                    </a:r>
                    <a:r>
                      <a:rPr lang="en-GB" sz="1100" dirty="0" smtClean="0"/>
                      <a:t>  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A</a:t>
                    </a:r>
                    <a:r>
                      <a:rPr lang="en-GB" sz="1100" dirty="0" smtClean="0"/>
                      <a:t>  G  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A  </a:t>
                    </a:r>
                    <a:r>
                      <a:rPr lang="en-GB" sz="1100" dirty="0" err="1" smtClean="0">
                        <a:solidFill>
                          <a:srgbClr val="00B050"/>
                        </a:solidFill>
                      </a:rPr>
                      <a:t>A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  </a:t>
                    </a:r>
                    <a:r>
                      <a:rPr lang="en-GB" sz="1100" dirty="0" err="1" smtClean="0">
                        <a:solidFill>
                          <a:srgbClr val="00B050"/>
                        </a:solidFill>
                      </a:rPr>
                      <a:t>A</a:t>
                    </a:r>
                    <a:r>
                      <a:rPr lang="en-GB" sz="1100" dirty="0" smtClean="0">
                        <a:solidFill>
                          <a:srgbClr val="00B050"/>
                        </a:solidFill>
                      </a:rPr>
                      <a:t>  </a:t>
                    </a:r>
                    <a:r>
                      <a:rPr lang="en-GB" sz="1100" dirty="0" smtClean="0"/>
                      <a:t>G  </a:t>
                    </a:r>
                    <a:r>
                      <a:rPr lang="en-GB" sz="1100" dirty="0" smtClean="0">
                        <a:solidFill>
                          <a:srgbClr val="FF0000"/>
                        </a:solidFill>
                      </a:rPr>
                      <a:t>T</a:t>
                    </a:r>
                    <a:endParaRPr lang="en-GB" sz="1100" dirty="0">
                      <a:solidFill>
                        <a:srgbClr val="FF0000"/>
                      </a:solidFill>
                    </a:endParaRPr>
                  </a:p>
                </p:txBody>
              </p:sp>
              <p:cxnSp>
                <p:nvCxnSpPr>
                  <p:cNvPr id="17" name="Straight Connector 16"/>
                  <p:cNvCxnSpPr/>
                  <p:nvPr/>
                </p:nvCxnSpPr>
                <p:spPr>
                  <a:xfrm>
                    <a:off x="845792" y="3599438"/>
                    <a:ext cx="360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Connector 17"/>
                  <p:cNvCxnSpPr/>
                  <p:nvPr/>
                </p:nvCxnSpPr>
                <p:spPr>
                  <a:xfrm>
                    <a:off x="413792" y="3599438"/>
                    <a:ext cx="360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Connector 18"/>
                  <p:cNvCxnSpPr/>
                  <p:nvPr/>
                </p:nvCxnSpPr>
                <p:spPr>
                  <a:xfrm>
                    <a:off x="251520" y="3599438"/>
                    <a:ext cx="1188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Connector 19"/>
                  <p:cNvCxnSpPr/>
                  <p:nvPr/>
                </p:nvCxnSpPr>
                <p:spPr>
                  <a:xfrm>
                    <a:off x="1259632" y="3599438"/>
                    <a:ext cx="2376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" name="TextBox 20"/>
                  <p:cNvSpPr txBox="1"/>
                  <p:nvPr/>
                </p:nvSpPr>
                <p:spPr>
                  <a:xfrm>
                    <a:off x="743199" y="3395919"/>
                    <a:ext cx="60785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/>
                      <a:t>K</a:t>
                    </a:r>
                    <a:r>
                      <a:rPr lang="en-GB" sz="1000" baseline="30000" dirty="0" smtClean="0"/>
                      <a:t>700/</a:t>
                    </a:r>
                    <a:r>
                      <a:rPr lang="en-GB" sz="1000" dirty="0" smtClean="0">
                        <a:solidFill>
                          <a:srgbClr val="FF0000"/>
                        </a:solidFill>
                      </a:rPr>
                      <a:t>E</a:t>
                    </a:r>
                    <a:r>
                      <a:rPr lang="en-GB" sz="1000" baseline="30000" dirty="0" smtClean="0">
                        <a:solidFill>
                          <a:srgbClr val="FF0000"/>
                        </a:solidFill>
                      </a:rPr>
                      <a:t>700</a:t>
                    </a:r>
                    <a:endParaRPr lang="en-GB" sz="1000" baseline="30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22" name="TextBox 21"/>
                  <p:cNvSpPr txBox="1"/>
                  <p:nvPr/>
                </p:nvSpPr>
                <p:spPr>
                  <a:xfrm>
                    <a:off x="384834" y="3394447"/>
                    <a:ext cx="44275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smtClean="0"/>
                      <a:t>Q</a:t>
                    </a:r>
                    <a:r>
                      <a:rPr lang="en-GB" sz="1200" baseline="30000" dirty="0"/>
                      <a:t>6</a:t>
                    </a:r>
                    <a:r>
                      <a:rPr lang="en-GB" sz="1200" baseline="30000" dirty="0" smtClean="0"/>
                      <a:t>99</a:t>
                    </a:r>
                    <a:endParaRPr lang="en-GB" sz="1200" baseline="30000" dirty="0"/>
                  </a:p>
                </p:txBody>
              </p:sp>
            </p:grpSp>
            <p:sp>
              <p:nvSpPr>
                <p:cNvPr id="12" name="TextBox 11"/>
                <p:cNvSpPr txBox="1"/>
                <p:nvPr/>
              </p:nvSpPr>
              <p:spPr>
                <a:xfrm rot="16200000">
                  <a:off x="1708112" y="913815"/>
                  <a:ext cx="95731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ealthy control</a:t>
                  </a:r>
                  <a:endPara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 rot="16200000">
                  <a:off x="1706509" y="2412157"/>
                  <a:ext cx="96051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DS </a:t>
                  </a:r>
                  <a:r>
                    <a:rPr lang="en-GB" sz="900" b="1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F3B1</a:t>
                  </a:r>
                  <a:r>
                    <a:rPr lang="en-GB" sz="9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GB" sz="900" b="1" baseline="30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T</a:t>
                  </a:r>
                  <a:endParaRPr lang="en-GB" sz="9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 rot="16200000">
                  <a:off x="1723311" y="4042717"/>
                  <a:ext cx="101181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DS </a:t>
                  </a:r>
                  <a:r>
                    <a:rPr lang="en-GB" sz="900" b="1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F3B1</a:t>
                  </a:r>
                  <a:r>
                    <a:rPr lang="en-GB" sz="9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GB" sz="900" b="1" baseline="30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UT</a:t>
                  </a:r>
                  <a:endParaRPr lang="en-GB" sz="9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" name="TextBox 7"/>
              <p:cNvSpPr txBox="1"/>
              <p:nvPr/>
            </p:nvSpPr>
            <p:spPr>
              <a:xfrm>
                <a:off x="0" y="-6326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" name="Rectangle 5"/>
            <p:cNvSpPr/>
            <p:nvPr/>
          </p:nvSpPr>
          <p:spPr>
            <a:xfrm>
              <a:off x="864000" y="3356992"/>
              <a:ext cx="27443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00" dirty="0"/>
                <a:t>G</a:t>
              </a:r>
            </a:p>
          </p:txBody>
        </p:sp>
      </p:grpSp>
      <p:grpSp>
        <p:nvGrpSpPr>
          <p:cNvPr id="42" name="Group 41"/>
          <p:cNvGrpSpPr>
            <a:grpSpLocks noChangeAspect="1"/>
          </p:cNvGrpSpPr>
          <p:nvPr/>
        </p:nvGrpSpPr>
        <p:grpSpPr>
          <a:xfrm>
            <a:off x="2501934" y="2338111"/>
            <a:ext cx="4273572" cy="1864221"/>
            <a:chOff x="2281422" y="94239"/>
            <a:chExt cx="6105103" cy="2663173"/>
          </a:xfrm>
        </p:grpSpPr>
        <p:sp>
          <p:nvSpPr>
            <p:cNvPr id="43" name="TextBox 42"/>
            <p:cNvSpPr txBox="1"/>
            <p:nvPr/>
          </p:nvSpPr>
          <p:spPr>
            <a:xfrm>
              <a:off x="2281422" y="94239"/>
              <a:ext cx="501969" cy="5276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pic>
          <p:nvPicPr>
            <p:cNvPr id="44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86525" y="595347"/>
              <a:ext cx="5400000" cy="21620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5" name="TextBox 44"/>
            <p:cNvSpPr txBox="1"/>
            <p:nvPr/>
          </p:nvSpPr>
          <p:spPr>
            <a:xfrm rot="16200000">
              <a:off x="2425795" y="807962"/>
              <a:ext cx="875240" cy="329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TRA 1-60</a:t>
              </a:r>
              <a:endParaRPr lang="en-GB" sz="900" b="1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2425795" y="1495871"/>
              <a:ext cx="875240" cy="329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TRA 1-81</a:t>
              </a:r>
              <a:endParaRPr lang="en-GB" sz="900" b="1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2521975" y="2158739"/>
              <a:ext cx="682880" cy="329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SSEA4</a:t>
              </a:r>
              <a:endParaRPr lang="en-GB" sz="900" b="1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186215" y="289958"/>
              <a:ext cx="1671613" cy="3957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Healthy control</a:t>
              </a:r>
              <a:endParaRPr lang="en-GB" sz="1200" b="1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876848" y="289958"/>
              <a:ext cx="1667581" cy="3957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SF3B1 wildtype</a:t>
              </a:r>
              <a:endParaRPr lang="en-GB" sz="1200" b="1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6678871" y="289958"/>
              <a:ext cx="1537510" cy="3957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SF3B1 mutant</a:t>
              </a:r>
              <a:endParaRPr lang="en-GB" sz="1200" b="1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3329608" y="261442"/>
            <a:ext cx="2664296" cy="1998816"/>
            <a:chOff x="2924944" y="178342"/>
            <a:chExt cx="2664296" cy="1998816"/>
          </a:xfrm>
        </p:grpSpPr>
        <p:grpSp>
          <p:nvGrpSpPr>
            <p:cNvPr id="39" name="Group 38"/>
            <p:cNvGrpSpPr/>
            <p:nvPr/>
          </p:nvGrpSpPr>
          <p:grpSpPr>
            <a:xfrm>
              <a:off x="2924944" y="178342"/>
              <a:ext cx="2664296" cy="1652595"/>
              <a:chOff x="87782" y="4848189"/>
              <a:chExt cx="2231161" cy="1394392"/>
            </a:xfrm>
          </p:grpSpPr>
          <p:pic>
            <p:nvPicPr>
              <p:cNvPr id="40" name="Picture 2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4041"/>
              <a:stretch/>
            </p:blipFill>
            <p:spPr bwMode="auto">
              <a:xfrm>
                <a:off x="148579" y="5063470"/>
                <a:ext cx="2170364" cy="11791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1" name="TextBox 40"/>
              <p:cNvSpPr txBox="1"/>
              <p:nvPr/>
            </p:nvSpPr>
            <p:spPr>
              <a:xfrm>
                <a:off x="87782" y="4848189"/>
                <a:ext cx="283515" cy="3116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 rot="19138463">
              <a:off x="3197275" y="1838604"/>
              <a:ext cx="551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sitive </a:t>
              </a:r>
            </a:p>
            <a:p>
              <a:pPr algn="ctr"/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 rot="19331820">
              <a:off x="3614844" y="1804205"/>
              <a:ext cx="4972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</a:t>
              </a:r>
            </a:p>
            <a:p>
              <a:pPr algn="ctr"/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 rot="19033803">
              <a:off x="3963750" y="1796265"/>
              <a:ext cx="5902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S </a:t>
              </a:r>
            </a:p>
            <a:p>
              <a:pPr algn="ctr"/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3B1</a:t>
              </a:r>
              <a:r>
                <a:rPr lang="en-GB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n-GB" sz="8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 rot="19211112">
              <a:off x="4337752" y="1804630"/>
              <a:ext cx="6270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S</a:t>
              </a:r>
            </a:p>
            <a:p>
              <a:pPr algn="ctr"/>
              <a:r>
                <a:rPr lang="en-GB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F3B1</a:t>
              </a:r>
              <a:r>
                <a:rPr lang="en-GB" sz="8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t</a:t>
              </a:r>
              <a:endParaRPr lang="en-GB" sz="8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8" name="TextBox 57"/>
          <p:cNvSpPr txBox="1"/>
          <p:nvPr/>
        </p:nvSpPr>
        <p:spPr>
          <a:xfrm>
            <a:off x="283229" y="504065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307565" y="50667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0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8361" y="5436096"/>
            <a:ext cx="3563040" cy="36724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858" y="5559852"/>
            <a:ext cx="2932684" cy="35366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2" name="TextBox 61"/>
          <p:cNvSpPr txBox="1"/>
          <p:nvPr/>
        </p:nvSpPr>
        <p:spPr>
          <a:xfrm>
            <a:off x="11643" y="33597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 </a:t>
            </a:r>
            <a:r>
              <a:rPr lang="en-GB" dirty="0" smtClean="0"/>
              <a:t>S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0997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98</TotalTime>
  <Words>69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lini Singh</dc:creator>
  <cp:lastModifiedBy>andreap</cp:lastModifiedBy>
  <cp:revision>291</cp:revision>
  <cp:lastPrinted>2019-11-10T17:33:11Z</cp:lastPrinted>
  <dcterms:created xsi:type="dcterms:W3CDTF">2019-09-05T11:00:27Z</dcterms:created>
  <dcterms:modified xsi:type="dcterms:W3CDTF">2019-11-19T14:10:11Z</dcterms:modified>
</cp:coreProperties>
</file>